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44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48A855D-0121-873F-83E6-161B25B7AF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8435775-CAC1-F471-9EC2-4F4443C2C0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255960B-4F64-2692-BBF8-69F8D46BC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3782A8D-8EE1-C4CD-14F5-8F55C01A9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FE1E2A-F8E4-3366-8431-F933BBC75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6054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6CCCC23-08FF-21D7-4996-C2AD93460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CA05135-D4AE-008F-17CA-0E9AE50123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91C1402-D561-7388-10F8-FE85CFDC9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77201FE-6EBA-4CF1-984A-6F429A6E9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92C9F65-AA86-BD71-AF95-D03E22ABD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33714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97C41D6-F6DF-C977-92E6-4ABA82D596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2616F6C-D8D0-2DDC-8C86-D4D97FC5DD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2C2ED64-A965-D1D1-285B-3F8882C96C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D9626E9-53AF-641D-284E-C7377B723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72CF66E-8BE8-CDA0-66BA-092DF463B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347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52CDC3-24F3-F27A-FAD9-4115FF5D5D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2CB63F5-1078-B489-A2C6-B5532BDA8A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4A433B3-3324-CA27-2786-BA87F064C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6D43866-0E01-5C7E-963E-C0B55E273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086CEDC-FB8A-BF1A-6D1B-F3811F823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7483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A211C0E-7711-D308-2D03-8EF753928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CF9337D-CAA2-FA57-0EF1-561BE9B6B2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2B5F023-6C4B-DF79-D847-E5544DEDB5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328F49E-7766-A5D2-1EBA-39A1FC8AEF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64323B0-CE8B-71DC-FCFA-E9DF7E37B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7012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93C2245-5F53-7E9D-73E8-6B17030545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17F25EE-B78C-1135-AAE3-B37DC2DA6D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931C6AE-DC3E-CCF6-4630-505AD059DE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40D2DB4-E41C-3950-91DA-F7854D0E4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54709F2-47A7-E067-CF1D-3A067FD24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BEA075D-34B5-BE15-067C-6F88975B5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6224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D4B238-69D6-A5E9-11DA-8F18AC01AC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339A6E4-D58E-9F2E-A630-0900CC0908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4A9AC9E-BB05-7935-B627-C1AE85001D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06E5F64-0A0B-00F3-D1A7-24C2B4F796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B4FF973-0000-6457-F1D4-883D0CBE8C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E02404B-CFAD-27AA-CC59-1828A2425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9AC0F51-5AE2-61C6-F7B8-2FFCEDACA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6B2F672-7B07-7175-B7F5-DE2C207A0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394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3B0F4E-9088-0D82-1363-F7F792C0D3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F9483B4-1C7E-C6CD-0693-76B7A648F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73813BE-6B90-3E5C-05FD-298235041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D12D67D-1D56-C2FD-48A9-BFA96F6E2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3818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4D71ACC-9D28-D25C-6AD5-081CF7A2F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9C84CE0A-029F-1D13-2235-9B9204440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1AA58EB-3657-0227-BF3E-7344B2B88D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9748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5968C9C-A433-FA62-6924-976D8EC3D7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EC4C7C8-1F37-EE99-946A-5B7E09836C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B5F04EC-CC4C-CF2E-6D98-20C4573F54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41DEE9F-7CC5-2FD9-516E-353FE07C77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543269E-2AF1-6D52-773E-1CC8195EE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895498B-F700-DE35-B9A1-89373607F0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65712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C666168-2A92-3119-3FDD-0F4AEABE70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4FD5047-0DD3-FFB1-1B66-BB40553C9B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BAB6B6E-A612-1F95-599A-0EFD5700FF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9ECD442-7DAC-EF40-C616-9CFE9425E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CD24F1D-65B1-9CA4-42FD-E97397705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499D159-BB4E-F71A-7338-35026CA64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25425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47FB9B53-AF4B-9498-6376-537F879016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230074A-9B5D-2057-B93A-5AF0697F6B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A4820A4-FB9E-4E5F-5FAD-93BDB1CB50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E0187-56D5-48D7-9FFE-7B2FBB0D839E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48F9CB3-C9EB-6663-5575-D1892293A2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B4A5A6D-EF8B-C362-1C8B-C9BB08F09B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618B0-FA13-4A00-9979-9EB35AA28E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112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B0B3BDD0-93E6-4B91-8100-651085890A36}"/>
              </a:ext>
            </a:extLst>
          </p:cNvPr>
          <p:cNvSpPr txBox="1"/>
          <p:nvPr/>
        </p:nvSpPr>
        <p:spPr>
          <a:xfrm>
            <a:off x="663045" y="6205136"/>
            <a:ext cx="107223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XfcdpmAdvTT3713a231"/>
                <a:cs typeface="Times New Roman" panose="02020603050405020304" pitchFamily="18" charset="0"/>
              </a:rPr>
              <a:t>Supplementary Figure S2. 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XfcdpmAdvTT3713a231"/>
                <a:cs typeface="Times New Roman" panose="02020603050405020304" pitchFamily="18" charset="0"/>
              </a:rPr>
              <a:t>Sequence coverage of the HC and LC of mAb675 products migrating at 150 </a:t>
            </a:r>
            <a:r>
              <a:rPr lang="en-US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XfcdpmAdvTT3713a231"/>
                <a:cs typeface="Times New Roman" panose="02020603050405020304" pitchFamily="18" charset="0"/>
              </a:rPr>
              <a:t>kDa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XfcdpmAdvTT3713a231"/>
                <a:cs typeface="Times New Roman" panose="02020603050405020304" pitchFamily="18" charset="0"/>
              </a:rPr>
              <a:t> and 50 </a:t>
            </a:r>
            <a:r>
              <a:rPr lang="en-US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XfcdpmAdvTT3713a231"/>
                <a:cs typeface="Times New Roman" panose="02020603050405020304" pitchFamily="18" charset="0"/>
              </a:rPr>
              <a:t>kDa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XfcdpmAdvTT3713a231"/>
                <a:cs typeface="Times New Roman" panose="02020603050405020304" pitchFamily="18" charset="0"/>
              </a:rPr>
              <a:t> in non-reducing SDS-PAGE. Data derive from peptide mapping experiments on corresponding tryptic digests that were performed through MALDI-TOF-MS analysis. The identified peptides are underlined and in red. The glycopeptide (in bold) was only detected by </a:t>
            </a:r>
            <a:r>
              <a:rPr lang="en-US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XfcdpmAdvTT3713a231"/>
                <a:cs typeface="Times New Roman" panose="02020603050405020304" pitchFamily="18" charset="0"/>
              </a:rPr>
              <a:t>nanoLC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XfcdpmAdvTT3713a231"/>
                <a:cs typeface="Times New Roman" panose="02020603050405020304" pitchFamily="18" charset="0"/>
              </a:rPr>
              <a:t>-ESI-Q-Orbitrap-MS/MS analysis. The leader peptides are reported in italics</a:t>
            </a:r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XfcdpmAdvTT3713a231"/>
                <a:cs typeface="Times New Roman" panose="02020603050405020304" pitchFamily="18" charset="0"/>
              </a:rPr>
              <a:t>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51DF4B7E-6A6A-FA1C-1035-92CDF023A4E8}"/>
              </a:ext>
            </a:extLst>
          </p:cNvPr>
          <p:cNvSpPr txBox="1"/>
          <p:nvPr/>
        </p:nvSpPr>
        <p:spPr>
          <a:xfrm>
            <a:off x="2977264" y="401989"/>
            <a:ext cx="6093912" cy="55171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ab675-HC – 150 </a:t>
            </a:r>
            <a:r>
              <a:rPr lang="en-US" sz="1100" b="1" dirty="0" err="1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KDa</a:t>
            </a:r>
            <a:r>
              <a:rPr lang="en-US" sz="11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 band</a:t>
            </a:r>
            <a:endParaRPr lang="it-IT" sz="1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i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GFVLFSQLPSFLLVSTLLLFLVISHSCRA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EVQLVESGGGLIQPGGSLRLS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44546A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ASGFTVSSNYMYWVRQAPGKGLEWVSVIFSGGSTFYADSVKGRFTISRDSSKNTLYLQMNSLRAEDTAVYY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44546A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RGPYPAADNYWGQGTLVTVSSASTKGPSVFPLAPSSKSTSGGTAALGCLVK</a:t>
            </a:r>
            <a:r>
              <a:rPr lang="en-US" sz="1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DYFPEPVTVSWNSGALTSGVHTFPAVLQSSGLYSLSSVVTVPSSSLGTQTYI</a:t>
            </a:r>
            <a:r>
              <a:rPr lang="en-US" sz="1100" dirty="0">
                <a:solidFill>
                  <a:srgbClr val="44546A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</a:t>
            </a:r>
            <a:r>
              <a:rPr lang="en-US" sz="1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NVNHKPSNTKVDKKAEPKS</a:t>
            </a:r>
            <a:r>
              <a:rPr lang="en-US" sz="1100" dirty="0">
                <a:solidFill>
                  <a:srgbClr val="44546A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</a:t>
            </a:r>
            <a:r>
              <a:rPr lang="en-US" sz="1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DK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HTCPPCPAPELLGGPSVFLFPPKPKDTLMISRTPEVTCVVVDVSHEDPEVKFNWYVDGVEVHNAK</a:t>
            </a:r>
            <a:r>
              <a:rPr lang="en-US" sz="1100" b="1" u="sng" dirty="0">
                <a:solidFill>
                  <a:srgbClr val="FF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KPREEQYNSTY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RVVSVLTVLHQDWLNGKEYK</a:t>
            </a:r>
            <a:r>
              <a:rPr lang="en-US" sz="1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KVSNKALPAPIEKTISKAKGQPR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EPQVYTLPPSRDELTKNQVSLTCLVKGFYPSDIAVEWESNGQPENNYKTTPPVLDSDGSFFLYSK</a:t>
            </a:r>
            <a:r>
              <a:rPr lang="en-US" sz="1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LTVDK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SRWQQGNVFSCSVMHEALHNHYTQK</a:t>
            </a:r>
            <a:r>
              <a:rPr lang="en-US" sz="1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SLSLSPGK</a:t>
            </a:r>
            <a:endParaRPr lang="it-IT" sz="1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ab675-LC - 150 </a:t>
            </a:r>
            <a:r>
              <a:rPr lang="en-US" sz="1100" b="1" dirty="0" err="1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KDa</a:t>
            </a:r>
            <a:r>
              <a:rPr lang="en-US" sz="11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 band</a:t>
            </a:r>
            <a:endParaRPr lang="it-IT" sz="1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i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GFVLFSQLPSFLLVSTLLLFLVISHSCRA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DIQMTQSPSSLSASVGDRVTITCQASQDISNYLNWYQQKPGKAPKLLIYDASNLETGVPSRFSGSGSGTDFTFTISSLQPEDIATYYCQQYDNLPITFGQGTR</a:t>
            </a:r>
            <a:r>
              <a:rPr lang="en-US" sz="1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LEIK</a:t>
            </a:r>
            <a:r>
              <a:rPr lang="en-US" sz="1100" u="sng" cap="all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rtvaapsvfifppsdeqlksgtasvvcllnnfypr</a:t>
            </a:r>
            <a:r>
              <a:rPr lang="en-US" sz="1100" cap="all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eak</a:t>
            </a:r>
            <a:r>
              <a:rPr lang="en-US" sz="1100" u="sng" cap="all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vqwkvdnalqsgnsqesvteqdskdstyslsstltlsk</a:t>
            </a:r>
            <a:r>
              <a:rPr lang="en-US" sz="1100" cap="all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dyekhkv</a:t>
            </a:r>
            <a:r>
              <a:rPr lang="en-US" sz="1100" u="sng" cap="all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yacevtHqgLSSPvtksfnrgec</a:t>
            </a:r>
            <a:endParaRPr lang="it-IT" sz="1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ab675-HC </a:t>
            </a:r>
            <a:r>
              <a:rPr lang="en-US" sz="1100" dirty="0">
                <a:solidFill>
                  <a:srgbClr val="202124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~</a:t>
            </a:r>
            <a:r>
              <a:rPr lang="en-US" sz="11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50 </a:t>
            </a:r>
            <a:r>
              <a:rPr lang="en-US" sz="1100" b="1" dirty="0" err="1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KDa</a:t>
            </a:r>
            <a:r>
              <a:rPr lang="en-US" sz="11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 band</a:t>
            </a:r>
            <a:endParaRPr lang="it-IT" sz="1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i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GFVLFSQLPSFLLVSTLLLFLVISHSCRA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C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EVQLVESGGGLIQPGGSLRLS</a:t>
            </a:r>
            <a:r>
              <a:rPr lang="en-US" sz="1100" b="1" u="sng" dirty="0">
                <a:solidFill>
                  <a:srgbClr val="FF0000"/>
                </a:solidFill>
                <a:effectLst/>
                <a:uFill>
                  <a:solidFill>
                    <a:srgbClr val="C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C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ASGFTVSSNYMYWVRQAPGKGLEWVSVIFSGGSTFYADSVKGRFTISRDSSKNTLYLQMNSLRAEDTAVYYCARGPYPAADNYWGQGTLVTVSSASTKGPSVFPLAPSSKSTSGGTAALGCLVKDYFPEPVTVSWNSGALTSGVHTFPAVLQSSGLYSLSSVVTVPSSSLGTQTYICNVNHKPSNTKVDKKAEPKSCDKTHTCPPCPAPELLGGPSVFLFPPKPK</a:t>
            </a:r>
            <a:r>
              <a:rPr lang="en-US" sz="1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DTLMISRTPEVTCVVVDVSHEDPEVKFNWYVDGVEVHNAKTKPREEQYNSTYRVVSVLTVLHQDWLNGKEYKCKVSNKALPAPIEKTISKAKGQPREPQVYTLPPSRDELTKNQVSLTCLVKGFYPSDIAVEWESNGQPENNYKTTPPVLDSDGSFFLYSKLTVDKSRWQQGNVFSCSVMHEALHNHYTQKSLSLSPGK </a:t>
            </a:r>
            <a:endParaRPr lang="it-IT" sz="1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ab675-LC </a:t>
            </a:r>
            <a:r>
              <a:rPr lang="en-US" sz="1100" dirty="0">
                <a:solidFill>
                  <a:srgbClr val="202124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~</a:t>
            </a:r>
            <a:r>
              <a:rPr lang="en-US" sz="11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50 </a:t>
            </a:r>
            <a:r>
              <a:rPr lang="en-US" sz="1100" b="1" dirty="0" err="1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KDa</a:t>
            </a:r>
            <a:r>
              <a:rPr lang="en-US" sz="11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 band</a:t>
            </a:r>
            <a:endParaRPr lang="it-IT" sz="1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i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GFVLFSQLPSFLLVSTLLLFLVISHSCRA</a:t>
            </a:r>
            <a:r>
              <a:rPr lang="en-US" sz="1100" u="sng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DIQMTQSPSSLSASVGDRVTITCQASQDISNYLNWYQQKPGKAPKLLIYDASNLETGVPSRFSGSGSGTDFTFTISSLQPEDIATYYCQQYDNLPITFGQGTR</a:t>
            </a:r>
            <a:r>
              <a:rPr lang="en-US" sz="1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LEIK</a:t>
            </a:r>
            <a:r>
              <a:rPr lang="en-US" sz="1100" u="sng" cap="all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rtvaapsvfifppsdeqlksgtasvvcllnnfypr</a:t>
            </a:r>
            <a:r>
              <a:rPr lang="en-US" sz="1100" cap="all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eak</a:t>
            </a:r>
            <a:r>
              <a:rPr lang="en-US" sz="1100" u="sng" cap="all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vqwkvdnalqsgnsqesvteqdskdstyslsstltlsk</a:t>
            </a:r>
            <a:r>
              <a:rPr lang="en-US" sz="1100" cap="all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dyekhkv</a:t>
            </a:r>
            <a:r>
              <a:rPr lang="en-US" sz="1100" u="sng" cap="all" dirty="0">
                <a:solidFill>
                  <a:srgbClr val="FF0000"/>
                </a:solidFill>
                <a:effectLst/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yacevtHqgLSSPvtksfnrgec</a:t>
            </a:r>
            <a:endParaRPr lang="it-IT" sz="1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101034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8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ello Donini</dc:creator>
  <cp:lastModifiedBy>Marcello Donini</cp:lastModifiedBy>
  <cp:revision>3</cp:revision>
  <dcterms:created xsi:type="dcterms:W3CDTF">2022-05-23T10:03:10Z</dcterms:created>
  <dcterms:modified xsi:type="dcterms:W3CDTF">2022-05-26T12:23:51Z</dcterms:modified>
</cp:coreProperties>
</file>